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010400" cy="923607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1" d="100"/>
          <a:sy n="71" d="100"/>
        </p:scale>
        <p:origin x="-1128" y="29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1763688" y="122975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b="1" dirty="0" smtClean="0"/>
              <a:t>A</a:t>
            </a:r>
            <a:endParaRPr lang="fr-FR" altLang="fr-FR" sz="1800" b="1" dirty="0"/>
          </a:p>
        </p:txBody>
      </p:sp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1781151" y="2499239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b="1" smtClean="0"/>
              <a:t>B</a:t>
            </a:r>
            <a:endParaRPr lang="fr-FR" altLang="fr-FR" sz="1800" b="1" dirty="0"/>
          </a:p>
        </p:txBody>
      </p:sp>
      <p:grpSp>
        <p:nvGrpSpPr>
          <p:cNvPr id="24" name="Groupe 23"/>
          <p:cNvGrpSpPr/>
          <p:nvPr/>
        </p:nvGrpSpPr>
        <p:grpSpPr>
          <a:xfrm>
            <a:off x="6780063" y="226978"/>
            <a:ext cx="399468" cy="2308323"/>
            <a:chOff x="6103605" y="665164"/>
            <a:chExt cx="399468" cy="2308323"/>
          </a:xfrm>
        </p:grpSpPr>
        <p:sp>
          <p:nvSpPr>
            <p:cNvPr id="11" name="ZoneTexte 10"/>
            <p:cNvSpPr txBox="1"/>
            <p:nvPr/>
          </p:nvSpPr>
          <p:spPr>
            <a:xfrm>
              <a:off x="6103605" y="665164"/>
              <a:ext cx="399468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27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14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69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07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6103605" y="1249939"/>
              <a:ext cx="399468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66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52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08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46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6104405" y="1834714"/>
              <a:ext cx="397866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106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9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47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5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6104406" y="2419489"/>
              <a:ext cx="397866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139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29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7</a:t>
              </a:r>
            </a:p>
            <a:p>
              <a:pPr algn="ctr"/>
              <a:r>
                <a:rPr lang="fr-CA" sz="7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25</a:t>
              </a:r>
            </a:p>
          </p:txBody>
        </p:sp>
      </p:grpSp>
      <p:grpSp>
        <p:nvGrpSpPr>
          <p:cNvPr id="25" name="Groupe 24"/>
          <p:cNvGrpSpPr/>
          <p:nvPr/>
        </p:nvGrpSpPr>
        <p:grpSpPr>
          <a:xfrm>
            <a:off x="2219748" y="194983"/>
            <a:ext cx="1134583" cy="2331790"/>
            <a:chOff x="1565209" y="665163"/>
            <a:chExt cx="1134583" cy="2331790"/>
          </a:xfrm>
        </p:grpSpPr>
        <p:sp>
          <p:nvSpPr>
            <p:cNvPr id="15" name="ZoneTexte 14"/>
            <p:cNvSpPr txBox="1"/>
            <p:nvPr/>
          </p:nvSpPr>
          <p:spPr>
            <a:xfrm>
              <a:off x="1566021" y="665163"/>
              <a:ext cx="113377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I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idecemlineat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sapiens</a:t>
              </a: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uscul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vegic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1636221" y="1242627"/>
              <a:ext cx="415499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66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52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08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46</a:t>
              </a: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1636220" y="1827402"/>
              <a:ext cx="415498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106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9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47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5</a:t>
              </a: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1636221" y="2412177"/>
              <a:ext cx="415498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139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29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87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25</a:t>
              </a: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1566021" y="1242626"/>
              <a:ext cx="113377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I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idecemlineat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sapiens</a:t>
              </a: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uscul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vegic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1565209" y="1834714"/>
              <a:ext cx="113377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I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idecemlineat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sapiens</a:t>
              </a: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uscul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vegic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1635409" y="2412178"/>
              <a:ext cx="415499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66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52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08</a:t>
              </a:r>
            </a:p>
            <a:p>
              <a:pPr algn="ctr"/>
              <a:r>
                <a:rPr lang="fr-CA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46</a:t>
              </a: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1565209" y="2412177"/>
              <a:ext cx="1133771" cy="58477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I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idecemlineat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. sapiens</a:t>
              </a: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uscul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fr-CA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. </a:t>
              </a:r>
              <a:r>
                <a:rPr lang="fr-CA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vegicus</a:t>
              </a:r>
              <a:endParaRPr lang="fr-CA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3" name="Image 2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4331" y="246397"/>
            <a:ext cx="3326589" cy="2269486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3519" y="2661046"/>
            <a:ext cx="3375043" cy="4068000"/>
          </a:xfrm>
          <a:prstGeom prst="rect">
            <a:avLst/>
          </a:prstGeom>
        </p:spPr>
      </p:pic>
      <p:sp>
        <p:nvSpPr>
          <p:cNvPr id="26" name="ZoneTexte 25"/>
          <p:cNvSpPr txBox="1"/>
          <p:nvPr/>
        </p:nvSpPr>
        <p:spPr>
          <a:xfrm>
            <a:off x="2219748" y="2560358"/>
            <a:ext cx="1133771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sapiens</a:t>
            </a: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scul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vegic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2219748" y="3088063"/>
            <a:ext cx="1133771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sapiens</a:t>
            </a: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scul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vegic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2219748" y="3615768"/>
            <a:ext cx="1133771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sapiens</a:t>
            </a: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scul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vegic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2219748" y="4116997"/>
            <a:ext cx="1133771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sapiens</a:t>
            </a: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scul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vegic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2219747" y="4644702"/>
            <a:ext cx="1133771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sapiens</a:t>
            </a: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scul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vegic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2219747" y="5177915"/>
            <a:ext cx="1133771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sapiens</a:t>
            </a: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scul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vegic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2219746" y="5696298"/>
            <a:ext cx="1133771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sapiens</a:t>
            </a: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scul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vegic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2219746" y="6212672"/>
            <a:ext cx="1133771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sapiens</a:t>
            </a: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scul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CA" sz="75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fr-CA" sz="75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vegicus</a:t>
            </a:r>
            <a:endParaRPr lang="fr-CA" sz="750" b="1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6779261" y="2578342"/>
            <a:ext cx="399468" cy="55399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18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65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880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719</a:t>
            </a:r>
          </a:p>
        </p:txBody>
      </p:sp>
      <p:sp>
        <p:nvSpPr>
          <p:cNvPr id="39" name="ZoneTexte 38"/>
          <p:cNvSpPr txBox="1"/>
          <p:nvPr/>
        </p:nvSpPr>
        <p:spPr>
          <a:xfrm>
            <a:off x="6779261" y="3101577"/>
            <a:ext cx="399468" cy="55399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58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904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920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759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6779261" y="3630476"/>
            <a:ext cx="399468" cy="55399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97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944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958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797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6780062" y="4153711"/>
            <a:ext cx="397865" cy="55399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129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976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998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833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6780062" y="4666919"/>
            <a:ext cx="397865" cy="55399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169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15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32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855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6780062" y="5205845"/>
            <a:ext cx="397865" cy="55399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207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47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66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889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6780062" y="5719053"/>
            <a:ext cx="397865" cy="55399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247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81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03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924</a:t>
            </a:r>
          </a:p>
        </p:txBody>
      </p:sp>
      <p:sp>
        <p:nvSpPr>
          <p:cNvPr id="45" name="ZoneTexte 44"/>
          <p:cNvSpPr txBox="1"/>
          <p:nvPr/>
        </p:nvSpPr>
        <p:spPr>
          <a:xfrm>
            <a:off x="6780062" y="6259378"/>
            <a:ext cx="397865" cy="55399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256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19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43</a:t>
            </a:r>
          </a:p>
          <a:p>
            <a:pPr algn="ctr"/>
            <a:r>
              <a:rPr lang="fr-CA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963</a:t>
            </a:r>
          </a:p>
        </p:txBody>
      </p:sp>
    </p:spTree>
    <p:extLst>
      <p:ext uri="{BB962C8B-B14F-4D97-AF65-F5344CB8AC3E}">
        <p14:creationId xmlns:p14="http://schemas.microsoft.com/office/powerpoint/2010/main" val="1615109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0</TotalTime>
  <Words>250</Words>
  <Application>Microsoft Office PowerPoint</Application>
  <PresentationFormat>全屏显示(4:3)</PresentationFormat>
  <Paragraphs>11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Thème Office</vt:lpstr>
      <vt:lpstr>PowerPoint 演示文稿</vt:lpstr>
    </vt:vector>
  </TitlesOfParts>
  <Company>universtié de monc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usager</dc:creator>
  <cp:lastModifiedBy>谢珊珊</cp:lastModifiedBy>
  <cp:revision>60</cp:revision>
  <cp:lastPrinted>2016-02-18T14:52:07Z</cp:lastPrinted>
  <dcterms:created xsi:type="dcterms:W3CDTF">2012-07-24T13:52:45Z</dcterms:created>
  <dcterms:modified xsi:type="dcterms:W3CDTF">2016-04-17T13:01:41Z</dcterms:modified>
</cp:coreProperties>
</file>